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86575" cy="100187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517A9-4682-7CC5-9E2F-A8DEB7792D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EA67A8-B834-85E4-9134-F274D466BE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7B71C-C6F8-5391-12B2-83EA6C31B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1362FF-9B71-A273-8A1E-5EAFB2455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113CD3-5606-A5C1-740A-FCB3996D5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5073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5EDD8-EDE8-F0E1-739D-0F1B5CBE2B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4C0E06-2688-A3F4-797B-9273B1106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B573F0-1621-4819-696C-1CEE27BF01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E972B5-AE80-9574-62C2-03380CE22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16A0D-5E55-936C-4973-91FF44350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7243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E58897-76D1-2FAB-1CB6-CF929450F5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B2DE88-382C-F7FF-2196-C77D99ADAF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AEDC05-48DB-F491-B254-8A7FCB59A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B8DEA-1124-F0E3-B84C-137E104BBB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69FDF2-FD8F-411F-FB88-F55BCACD6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7502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BD473-1000-E8B8-CC4D-F93F16B9B1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92258D-715F-BB53-720F-99538AE15C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74966C-FD6D-5F85-D883-6927D0BF8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982493-002F-A197-B592-7F1D219E5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1B0CE8-5816-731C-3593-1797FCEC8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503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E48EB-3934-BA0D-0A43-43FA7835BA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C7D9A4-B9C8-61FA-8F31-548EC94DDF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FD149D-0303-BEE1-6720-36855F177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EAD292-AFDF-5F98-2C25-B82CB58C9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F5F779-2190-9C85-EF99-57760FA24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46761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70DDF1-C4F2-A03E-062D-32DF081A7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769602-E034-8F58-433A-571F3251A6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FFB6C5-4469-907D-6080-8BF9639185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6C9318-094E-10E5-DDDE-147D17919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37587D-CC2B-2EDE-CDCA-6D7DD3DF8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BA04BD-B5AF-D34A-EAEC-8AF96B6A5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85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A71FB-56C7-1297-FB89-A515398F8D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62F48-CA04-8BD1-FD65-630A985A7A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EA737A-F45D-40A3-2325-32B0C7217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816C9E-6B4D-DC24-7E91-F552A42F2B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F7FB04-D3BC-970B-D6BC-C2EAF07202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A7DFE2-1AC2-0241-FA9A-51D920C2F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BAAB29-E269-4790-EB3A-B06DB191A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9E6C2A-3EC6-D298-9744-FFFF745AB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716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711A0-3ABC-DD2E-9B47-54DB544CA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FDB24C-54CC-A48E-C253-CB85240B0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FAE578-9AB0-C011-674B-12A3CB225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BA8515-AD99-DA04-4E0B-DB8ADD1A6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892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636936-536F-9E9D-1459-9334AE412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70DAAE-DFA6-EAE1-18C7-6676F92A6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285A75-AC75-5AF0-2DEF-E2DAD6976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9085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95F5D1-64C6-EC7C-A35E-49E37153EB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04E868-4654-5E88-D459-90C2F51AB5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9F9EF2-ADF8-EA77-C3DB-183BF2D8CD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EA17F2-D089-F7F2-22FA-699F4F526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3C8FED-BF08-BD67-44E0-F6037529E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D58144-1DA5-5515-395A-85CF492C4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972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C18101-BBC4-4A16-C8F6-A21344C88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14B86B-AADA-A420-5892-12868F1126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379D52-5A93-8B23-D1E9-87655A66B8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052EF0-DB57-ECFC-4D94-43B351346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66C5F0-511A-B8E6-93EB-506E608E1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8E7F98-5FE6-43A1-C07A-0E7B4BD4D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0578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86FA74-B898-9AF6-96BC-7FEE72AA3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14924A-E52E-1779-57B9-C4E3DE86DC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5019F5-C883-9983-95B4-3A3E573C33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25D15-F7F5-4940-A98F-17184AE13F0F}" type="datetimeFigureOut">
              <a:rPr lang="en-GB" smtClean="0"/>
              <a:t>08/03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7E472A-B05D-9A0F-923C-48CA3471DB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204C5-C8C2-8CA2-68FA-3E440706DC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61124-8A40-439A-8E9B-56E6835964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5719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3EBD193B-564F-AA37-0603-971BD20EF1F0}"/>
              </a:ext>
            </a:extLst>
          </p:cNvPr>
          <p:cNvSpPr txBox="1"/>
          <p:nvPr/>
        </p:nvSpPr>
        <p:spPr>
          <a:xfrm>
            <a:off x="868134" y="5215720"/>
            <a:ext cx="1107238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Footnotes: </a:t>
            </a:r>
          </a:p>
          <a:p>
            <a:r>
              <a:rPr lang="en-GB" sz="1100" baseline="30000" dirty="0"/>
              <a:t>1 </a:t>
            </a:r>
            <a:r>
              <a:rPr lang="en-GB" sz="1100" dirty="0"/>
              <a:t>Plots show predicted margins with 95% CIs.</a:t>
            </a:r>
          </a:p>
          <a:p>
            <a:r>
              <a:rPr lang="en-GB" sz="1100" baseline="30000" dirty="0"/>
              <a:t>2</a:t>
            </a:r>
            <a:r>
              <a:rPr lang="en-GB" sz="1100" dirty="0"/>
              <a:t> Adjusted for Age, %mammographic density, Breast Volume (omitted in pressure models due to collinearity). </a:t>
            </a:r>
          </a:p>
          <a:p>
            <a:r>
              <a:rPr lang="en-GB" sz="1100" baseline="30000" dirty="0"/>
              <a:t>3</a:t>
            </a:r>
            <a:r>
              <a:rPr lang="en-GB" sz="1100" dirty="0"/>
              <a:t> Pressure models additionally adjusted for tilt. Force model additionally adjusted for tilt and vice versa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5F14918-A881-6C68-F904-E2B205D9B4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89" t="5598" b="5022"/>
          <a:stretch/>
        </p:blipFill>
        <p:spPr>
          <a:xfrm>
            <a:off x="1664264" y="575411"/>
            <a:ext cx="2683628" cy="173640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08CDAA6-DB63-BC25-F49E-B70785AE35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80" t="13347" b="5592"/>
          <a:stretch/>
        </p:blipFill>
        <p:spPr>
          <a:xfrm>
            <a:off x="7844107" y="572834"/>
            <a:ext cx="2762031" cy="178482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ABE353B-5331-3632-38C0-4ADD24BB0E5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64" t="5761" b="6150"/>
          <a:stretch/>
        </p:blipFill>
        <p:spPr>
          <a:xfrm>
            <a:off x="7911205" y="2643756"/>
            <a:ext cx="2694933" cy="175458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7F085CC-C9C9-E88F-1C2D-CFBA8208065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091" t="5824" b="6486"/>
          <a:stretch/>
        </p:blipFill>
        <p:spPr>
          <a:xfrm>
            <a:off x="1664264" y="2676415"/>
            <a:ext cx="2694933" cy="173640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6B29053-6038-E1B1-9A64-0DB15BE1D9C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235" t="5771" b="5660"/>
          <a:stretch/>
        </p:blipFill>
        <p:spPr>
          <a:xfrm>
            <a:off x="4714984" y="572834"/>
            <a:ext cx="2762031" cy="176815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594A57B-DA3A-824D-A1B6-7B10AB92B31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050" t="5491" b="7389"/>
          <a:stretch/>
        </p:blipFill>
        <p:spPr>
          <a:xfrm>
            <a:off x="4751075" y="2643756"/>
            <a:ext cx="2725940" cy="176815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A7C700F9-432E-A271-406E-A559697EA981}"/>
              </a:ext>
            </a:extLst>
          </p:cNvPr>
          <p:cNvSpPr txBox="1"/>
          <p:nvPr/>
        </p:nvSpPr>
        <p:spPr>
          <a:xfrm>
            <a:off x="868134" y="4909966"/>
            <a:ext cx="111839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</a:t>
            </a:r>
            <a:r>
              <a:rPr lang="en-GB" sz="1200" b="1"/>
              <a:t>Figure 3 </a:t>
            </a:r>
            <a:r>
              <a:rPr lang="en-GB" sz="1200" b="1" dirty="0"/>
              <a:t>Estimated exposure response curves</a:t>
            </a:r>
            <a:r>
              <a:rPr lang="en-GB" sz="1200" baseline="30000" dirty="0"/>
              <a:t>1</a:t>
            </a:r>
            <a:r>
              <a:rPr lang="en-GB" sz="1200" b="1" dirty="0"/>
              <a:t> for compression thickness in mutually adjusted</a:t>
            </a:r>
            <a:r>
              <a:rPr lang="en-GB" sz="1200" b="1" baseline="30000" dirty="0"/>
              <a:t>2,3</a:t>
            </a:r>
            <a:r>
              <a:rPr lang="en-GB" sz="1200" b="1" dirty="0"/>
              <a:t> linear and quadratic mode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6BFE989-F794-EF55-B6F7-1B90AD65F29E}"/>
              </a:ext>
            </a:extLst>
          </p:cNvPr>
          <p:cNvSpPr txBox="1"/>
          <p:nvPr/>
        </p:nvSpPr>
        <p:spPr>
          <a:xfrm>
            <a:off x="225885" y="1248815"/>
            <a:ext cx="985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redicted thickness mm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A73EDB1-4E92-FD06-4940-263010B89014}"/>
              </a:ext>
            </a:extLst>
          </p:cNvPr>
          <p:cNvSpPr txBox="1"/>
          <p:nvPr/>
        </p:nvSpPr>
        <p:spPr>
          <a:xfrm>
            <a:off x="225885" y="595658"/>
            <a:ext cx="17149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Linear regression models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4E723F-CD62-7485-DCD0-4172E6EEC675}"/>
              </a:ext>
            </a:extLst>
          </p:cNvPr>
          <p:cNvSpPr txBox="1"/>
          <p:nvPr/>
        </p:nvSpPr>
        <p:spPr>
          <a:xfrm>
            <a:off x="283368" y="2752812"/>
            <a:ext cx="17149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/>
              <a:t>Quadratic models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D15DB4-0D54-85F2-FDC4-ACDFD0265854}"/>
              </a:ext>
            </a:extLst>
          </p:cNvPr>
          <p:cNvSpPr txBox="1"/>
          <p:nvPr/>
        </p:nvSpPr>
        <p:spPr>
          <a:xfrm>
            <a:off x="283368" y="3336676"/>
            <a:ext cx="9855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redicted thickness m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1C41E8F-2272-99C6-28FD-B71B767FC094}"/>
              </a:ext>
            </a:extLst>
          </p:cNvPr>
          <p:cNvSpPr txBox="1"/>
          <p:nvPr/>
        </p:nvSpPr>
        <p:spPr>
          <a:xfrm>
            <a:off x="2545439" y="4468044"/>
            <a:ext cx="1568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Force </a:t>
            </a:r>
            <a:r>
              <a:rPr lang="en-GB" sz="1000" dirty="0" err="1"/>
              <a:t>daN</a:t>
            </a:r>
            <a:endParaRPr lang="en-GB" sz="1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F7C4C91-468E-EE36-C278-0375B8818C50}"/>
              </a:ext>
            </a:extLst>
          </p:cNvPr>
          <p:cNvSpPr txBox="1"/>
          <p:nvPr/>
        </p:nvSpPr>
        <p:spPr>
          <a:xfrm>
            <a:off x="5526249" y="4476045"/>
            <a:ext cx="1568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ressure kP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F3A1A3B-6EC3-BF70-A38E-9DD1CE1D863F}"/>
              </a:ext>
            </a:extLst>
          </p:cNvPr>
          <p:cNvSpPr txBox="1"/>
          <p:nvPr/>
        </p:nvSpPr>
        <p:spPr>
          <a:xfrm>
            <a:off x="8299182" y="4474828"/>
            <a:ext cx="20714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ddle tilt degrees from horizontal</a:t>
            </a:r>
          </a:p>
        </p:txBody>
      </p:sp>
    </p:spTree>
    <p:extLst>
      <p:ext uri="{BB962C8B-B14F-4D97-AF65-F5344CB8AC3E}">
        <p14:creationId xmlns:p14="http://schemas.microsoft.com/office/powerpoint/2010/main" val="8982577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8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e Hudson</dc:creator>
  <cp:lastModifiedBy>Sue</cp:lastModifiedBy>
  <cp:revision>9</cp:revision>
  <cp:lastPrinted>2022-11-10T14:40:04Z</cp:lastPrinted>
  <dcterms:created xsi:type="dcterms:W3CDTF">2022-11-10T14:35:12Z</dcterms:created>
  <dcterms:modified xsi:type="dcterms:W3CDTF">2023-03-08T19:10:33Z</dcterms:modified>
</cp:coreProperties>
</file>